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8622" autoAdjust="0"/>
    <p:restoredTop sz="94660"/>
  </p:normalViewPr>
  <p:slideViewPr>
    <p:cSldViewPr snapToGrid="0">
      <p:cViewPr varScale="1">
        <p:scale>
          <a:sx n="82" d="100"/>
          <a:sy n="82" d="100"/>
        </p:scale>
        <p:origin x="91" y="14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D1CC37-1CEE-4C47-199F-141E9E55F2B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F576212-7A79-9ACA-C74D-1EB47DE36B7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26F475-35B9-6226-33BE-27C788AD98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F287-DE19-42FF-8CC0-62009797AA2B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9F97DE-1FC0-EEFF-4FE8-0C396D318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64B1B5-D49E-036D-F3D4-CB042594AF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8BD3-DD5F-4993-9527-C69E27563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89374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518E4F-B5B5-E2AE-5073-32919E93E4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7DDB72-805E-2046-43B7-1D0EAAAC9E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4CFFAA-F29B-F1C0-70DC-E67F05A0E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F287-DE19-42FF-8CC0-62009797AA2B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7CA500-A474-7563-9FA5-3B4AF41A89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E93AA0-0D23-0394-8B34-FE88E76935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8BD3-DD5F-4993-9527-C69E27563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22166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3B3F1D9-47B8-627C-BC40-A26DCCD251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A94A24-8CA7-70BC-67EC-945483CFCE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5D1C53-C816-3937-C217-4606CBC04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F287-DE19-42FF-8CC0-62009797AA2B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F5DA46-BE50-1019-44C4-5A17847D7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49D08E-928F-2C64-3185-8242E513BB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8BD3-DD5F-4993-9527-C69E27563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1377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1726A7-E1DF-7A7C-221A-FD3FF0F131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B0DF0A-4D87-3538-FBF4-A6ED035F88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20A175-57BE-2E9C-2A21-A0415AAACE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F287-DE19-42FF-8CC0-62009797AA2B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FC4448-3CF4-CB0F-20EC-86ABBBF60B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00F67F-647B-53FB-4C34-BE1D472475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8BD3-DD5F-4993-9527-C69E27563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938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29B72D-4256-9D32-5817-30668A9A7E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1BF74F-F572-EA29-B06E-8DCC2929CC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7A6FEC-5252-2625-E117-9EF528E54E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F287-DE19-42FF-8CC0-62009797AA2B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667474-2AC8-1CE6-9D26-983D184A85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93A721-8BEC-F57A-362E-E570466620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8BD3-DD5F-4993-9527-C69E27563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674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D9095D-7182-B7CC-9DBA-13EB4ED0A0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9C3A62-D639-4870-820D-BA97178AEE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F9CF63-4DE7-5CED-3612-310F97A0F7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5D7984-29A6-1418-BA54-193FF92966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F287-DE19-42FF-8CC0-62009797AA2B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6CBB28-83C0-5563-776D-5AE6B686DC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A268F0-71AD-1CDD-0686-1FE7BB2074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8BD3-DD5F-4993-9527-C69E27563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99521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7F7324-0DBD-ACBB-3050-CA55EF35FB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8F4CDB-64C0-172E-E763-3CAEB539BF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CD089D-54DA-3743-5032-274B7AF0B9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1924A84-89AD-632A-D47E-E585F97678B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C8F056D-E0A9-16D8-FF37-1E87CB6543D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6DD1506-2122-FD5D-BB1D-1200BC365E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F287-DE19-42FF-8CC0-62009797AA2B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929553C-1273-D294-D00C-7BE34C4471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F7ED1F5-70BF-687F-A46D-F5928213C7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8BD3-DD5F-4993-9527-C69E27563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3126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6BF0FC-8939-130E-E404-99E443514A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F97E8A6-D12D-3C90-ACCE-4038105814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F287-DE19-42FF-8CC0-62009797AA2B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06C4C66-4B4B-F862-8BDB-8A8205E886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C125BAF-F03F-57FC-2DBD-1D644EF58C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8BD3-DD5F-4993-9527-C69E27563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7129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49BA7D1-E224-80EA-CE38-E49F993845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F287-DE19-42FF-8CC0-62009797AA2B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DB7CFBD-08F4-1B2E-B7D8-CE69F5A17B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1CEA865-71A4-DA71-48E2-CB5E5F6A1E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8BD3-DD5F-4993-9527-C69E27563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304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1DC46F-166B-CFEA-5BBB-3B7A065761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5B6D37-66D1-FFA2-A90A-4D965EF28EB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C3574DF-DE26-7DC4-1488-5159B2D654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A5865B-5E81-5512-D1E0-E59046695E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F287-DE19-42FF-8CC0-62009797AA2B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03FA5F7-E397-CF9E-91FB-235014BB3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0573F5-EB67-3C2F-FF51-BC84B24F4C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8BD3-DD5F-4993-9527-C69E27563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470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B4EF0B-24A0-E197-2184-971B033FC6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05D0A72-1B4B-ED09-4619-45D7672CA03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52AE040-678B-38E1-7233-72FFF6EAB7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096C19-8D70-344C-F865-5035D3939E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F287-DE19-42FF-8CC0-62009797AA2B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A86012-B3FC-67BC-3B18-DD5652C7A3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DC986C-F364-145F-868A-E1B2E4872C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8BD3-DD5F-4993-9527-C69E27563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332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E549150-5CD7-FE06-76DA-73DE2E33DC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115CBA-79A3-AA21-8895-B419FB3B67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D787A1-815B-9DA6-8F72-FF1B2CC4FFA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07F287-DE19-42FF-8CC0-62009797AA2B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BBD339-9DC9-6B8E-4320-8B2FA178D8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B314A3-E3CF-4480-860F-40229BB792F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3C8BD3-DD5F-4993-9527-C69E27563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5176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87B3FFD2-9AC6-F990-AC74-23EFD2C7F61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427224"/>
              </p:ext>
            </p:extLst>
          </p:nvPr>
        </p:nvGraphicFramePr>
        <p:xfrm>
          <a:off x="917244" y="221708"/>
          <a:ext cx="3894137" cy="2868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894705" imgH="2869254" progId="Prism10.Document">
                  <p:embed/>
                </p:oleObj>
              </mc:Choice>
              <mc:Fallback>
                <p:oleObj name="Prism 10" r:id="rId2" imgW="3894705" imgH="2869254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87B3FFD2-9AC6-F990-AC74-23EFD2C7F61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17244" y="221708"/>
                        <a:ext cx="3894137" cy="2868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5371215A-6D0F-EBCE-71A1-F2FFDCA6376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1909289"/>
              </p:ext>
            </p:extLst>
          </p:nvPr>
        </p:nvGraphicFramePr>
        <p:xfrm>
          <a:off x="6096000" y="294114"/>
          <a:ext cx="3744913" cy="3009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745684" imgH="3009639" progId="Prism10.Document">
                  <p:embed/>
                </p:oleObj>
              </mc:Choice>
              <mc:Fallback>
                <p:oleObj name="Prism 10" r:id="rId4" imgW="3745684" imgH="3009639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5371215A-6D0F-EBCE-71A1-F2FFDCA6376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096000" y="294114"/>
                        <a:ext cx="3744913" cy="3009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F33206E3-3145-72E2-CBEB-BC54E7653E83}"/>
              </a:ext>
            </a:extLst>
          </p:cNvPr>
          <p:cNvSpPr txBox="1"/>
          <p:nvPr/>
        </p:nvSpPr>
        <p:spPr>
          <a:xfrm>
            <a:off x="700709" y="343893"/>
            <a:ext cx="644055" cy="3724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)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F5A0571-FE2A-48EA-B549-BF5E6306435D}"/>
              </a:ext>
            </a:extLst>
          </p:cNvPr>
          <p:cNvSpPr txBox="1"/>
          <p:nvPr/>
        </p:nvSpPr>
        <p:spPr>
          <a:xfrm>
            <a:off x="5622566" y="312088"/>
            <a:ext cx="524786" cy="3724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)</a:t>
            </a:r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FCF1623-B51C-20D4-198F-49505370D64D}"/>
              </a:ext>
            </a:extLst>
          </p:cNvPr>
          <p:cNvSpPr txBox="1"/>
          <p:nvPr/>
        </p:nvSpPr>
        <p:spPr>
          <a:xfrm>
            <a:off x="917244" y="3000507"/>
            <a:ext cx="10430053" cy="25841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799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 F</a:t>
            </a:r>
            <a:r>
              <a:rPr lang="en-US" altLang="zh-CN" sz="1799" b="1" dirty="0" err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gure</a:t>
            </a:r>
            <a:r>
              <a:rPr lang="en-US" altLang="zh-CN" sz="1799" b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</a:t>
            </a:r>
            <a:r>
              <a:rPr lang="en-GB" sz="1799" b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GB" sz="1799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CD200 and PD1 expression on CD138+ PC in patients with PCD.</a:t>
            </a:r>
          </a:p>
          <a:p>
            <a:endParaRPr lang="en-GB" sz="1799" b="1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GB" sz="1799" kern="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D138 </a:t>
            </a:r>
            <a:r>
              <a:rPr lang="en-GB" sz="1799" kern="100" baseline="300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 </a:t>
            </a:r>
            <a:r>
              <a:rPr lang="en-GB" sz="1799" kern="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Cs were purified from fresh BMAs, from patients with MGUS , SMM, NDMM , RRMM and controls (MACS), stained with specific monoclonal antibodies and </a:t>
            </a:r>
            <a:r>
              <a:rPr lang="en-GB" sz="1799" kern="100" dirty="0" err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alyzed</a:t>
            </a:r>
            <a:r>
              <a:rPr lang="en-GB" sz="1799" kern="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y flow cytometry. </a:t>
            </a:r>
          </a:p>
          <a:p>
            <a:pPr marL="342900" indent="-342900">
              <a:buAutoNum type="alphaUcParenR"/>
            </a:pPr>
            <a:r>
              <a:rPr lang="en-GB" sz="1799" kern="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scriptive statistics of CD200 expression on CD138+ PC in patients with active MM (5), MGUS/SMM (7) and controls (5)</a:t>
            </a:r>
            <a:endParaRPr lang="en-US" sz="1799" kern="1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indent="-342900">
              <a:buAutoNum type="alphaUcParenR"/>
            </a:pPr>
            <a:r>
              <a:rPr lang="en-GB" sz="1799" kern="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scriptive statistics of PD1 expression on CD138+ PC in patients with active MM (9), MGUS/SMM (10) and controls (9)</a:t>
            </a:r>
            <a:endParaRPr lang="en-GB" sz="1799" b="1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sz="1799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97C7F1E-28C8-D398-4B0B-821669DC9358}"/>
              </a:ext>
            </a:extLst>
          </p:cNvPr>
          <p:cNvSpPr txBox="1"/>
          <p:nvPr/>
        </p:nvSpPr>
        <p:spPr>
          <a:xfrm>
            <a:off x="844703" y="5406265"/>
            <a:ext cx="9759819" cy="15706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1" b="1" dirty="0"/>
              <a:t>Abbreviations: </a:t>
            </a:r>
            <a:r>
              <a:rPr lang="en-GB" sz="1201" dirty="0"/>
              <a:t>LAG3-</a:t>
            </a:r>
            <a:r>
              <a:rPr lang="en-US" sz="1201" dirty="0"/>
              <a:t>Lymphocyte-activation gene 3</a:t>
            </a:r>
          </a:p>
          <a:p>
            <a:r>
              <a:rPr lang="en-US" sz="1201" dirty="0"/>
              <a:t>PD1-Programmed death-1 </a:t>
            </a:r>
          </a:p>
          <a:p>
            <a:r>
              <a:rPr lang="en-US" sz="1201" dirty="0"/>
              <a:t>PC-plasma cells</a:t>
            </a:r>
          </a:p>
          <a:p>
            <a:r>
              <a:rPr lang="en-GB" sz="1201" dirty="0"/>
              <a:t>MGUS-monoclonal gammopathy of undetermined significance</a:t>
            </a:r>
          </a:p>
          <a:p>
            <a:r>
              <a:rPr lang="en-GB" sz="1201" dirty="0"/>
              <a:t>SMM-</a:t>
            </a:r>
            <a:r>
              <a:rPr lang="en-GB" sz="1201" dirty="0" err="1"/>
              <a:t>smoldering</a:t>
            </a:r>
            <a:r>
              <a:rPr lang="en-GB" sz="1201" dirty="0"/>
              <a:t> multiple myeloma</a:t>
            </a:r>
          </a:p>
          <a:p>
            <a:r>
              <a:rPr lang="en-GB" sz="1201" dirty="0"/>
              <a:t>NDMM-newly diagnosed multiple myeloma</a:t>
            </a:r>
          </a:p>
          <a:p>
            <a:r>
              <a:rPr lang="en-GB" sz="1201" dirty="0"/>
              <a:t>RRMM-relapsed refractory multiple myeloma</a:t>
            </a:r>
            <a:endParaRPr lang="en-US" sz="1201" dirty="0"/>
          </a:p>
          <a:p>
            <a:endParaRPr lang="en-US" sz="1201" dirty="0"/>
          </a:p>
        </p:txBody>
      </p:sp>
    </p:spTree>
    <p:extLst>
      <p:ext uri="{BB962C8B-B14F-4D97-AF65-F5344CB8AC3E}">
        <p14:creationId xmlns:p14="http://schemas.microsoft.com/office/powerpoint/2010/main" val="1998247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7</TotalTime>
  <Words>140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10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talia Kreiniz</dc:creator>
  <cp:lastModifiedBy>MDPI</cp:lastModifiedBy>
  <cp:revision>6</cp:revision>
  <dcterms:created xsi:type="dcterms:W3CDTF">2023-11-04T16:47:33Z</dcterms:created>
  <dcterms:modified xsi:type="dcterms:W3CDTF">2023-12-28T07:01:29Z</dcterms:modified>
</cp:coreProperties>
</file>